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96"/>
    <p:restoredTop sz="94558"/>
  </p:normalViewPr>
  <p:slideViewPr>
    <p:cSldViewPr snapToGrid="0">
      <p:cViewPr varScale="1">
        <p:scale>
          <a:sx n="35" d="100"/>
          <a:sy n="35" d="100"/>
        </p:scale>
        <p:origin x="58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1CD874-2DA0-7506-A41C-8DDF556F6E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8E18151-B831-FF29-CC8C-0343B1C589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2F7FCB-E8DA-8838-1E6C-3BE274957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A25383-F8B8-5349-7C1C-193965AB0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7839CF-419F-15C5-62DA-E9379FB13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478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DAFF90-6D4C-6576-5067-3321E358CB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F6AEB2-31E9-48F6-23DC-D6D5DFA345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04D7DF-80B9-DAA8-A7DA-9B42F6C9D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B6B474-A4B3-F775-1B13-907DDA96E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182C5-D75D-FB07-C52D-04844E778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15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952FAD8-E539-6988-57BB-4E6A871EE9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473FBB-B833-9E0B-36E2-E6FC52E9D1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1660E9-A34C-6C33-5FE0-063D4E367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E05E65-94FE-CF31-06B5-601B96691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3D3D02-5713-835D-2293-05A3D7505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1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641E64-6889-0A49-D81B-512E4EA7C5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B4BFFA-CF9A-5D4E-FAA4-A87E6A7EAD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233C9D-690A-2BAA-97B4-C291ACE36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783835-8605-BA1F-055A-50B695F2A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6603DD-EF03-141F-6700-0955483AE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195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74E8F8-E13E-98E0-CBE9-C9E9D9E0A8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458611-1529-4751-64C4-766DDF6524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BAC572-C127-C561-E86E-CF1A6706A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9D2817-3BBB-7497-86E2-C2F29E639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00503B-F5CB-5BE7-99A7-EDBDC9248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611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FAFBE-7608-0726-6577-78A79A6A1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86C94F-FBEB-335E-0B89-860EACF601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B23B0E-9EE6-36D2-5049-F99CCF9EE9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9651A9-9940-48B1-95C8-2B1052466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933266-9ADF-B0EA-8BFC-09B625ED1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BF1A4A-8A3B-6FC4-B954-56F1B4F0B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37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BF1C0-DDF5-BE61-F3AB-C72ADC7EB5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D30B35-9E7C-6485-9015-5A723A4C8B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D2B1B9-9CA0-667A-4E60-7094E9E296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EFCE5C-9756-66EA-0433-711931DA3D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F9DAE4-4ADB-4C57-3268-28C58B8E34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E65A84E-CC10-6781-8ADC-0855E55DE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C98FEC-8FDC-7C85-DD12-4355FF08E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60F422-FB8A-B4B5-423A-7616E0EFE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058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894EF-261F-C0B9-00A0-F0DF26FCB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1C2BE1-557E-FF52-7E02-149B40B30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089943-1E04-0144-6BA4-F48017B88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F4D2E7-3F77-704D-2242-3BA9D4990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728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6609F2-24A9-8C5E-3F1B-70B0C7482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C9C216B-43F6-FE70-FDD7-A455E5587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4B19C3-9110-2A10-7F32-359D72039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579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D75362-0134-1812-1375-CCCE459947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59398E-5F50-1833-6029-68D64B7B5A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7DD7AA-9F4E-2F01-8D65-6D8041664A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71134F-BADF-4D5F-F518-A062651F0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685D61-C767-39FC-458B-0BF868749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81E2BC-6C11-851D-CCDA-8912BA14C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08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CE8F66-8893-FEA8-A182-04577FFCB1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F263E9-91C2-FEB2-99DB-75F4BF0DDB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CBD478-AF66-F77F-D155-445215AD5F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05A061-98F0-0522-BC97-24A177B5B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D4F473-B133-A8AD-33DC-B93426DD6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7C2A98-C54A-4C43-9689-EF4507E1C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65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3C33A1-5A1F-A21A-9CC7-27A1A2255A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84B825-D493-5B92-A0CE-F0555020BF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7CB982-DFCE-F78A-E74F-A1114D53DA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8BDCD7-1CC0-8C4E-9708-62E12A5148E2}" type="datetimeFigureOut">
              <a:rPr lang="en-US" smtClean="0"/>
              <a:t>6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672195-A0A5-AE23-4B00-17E3C9E54A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EA8D1C-64B3-D9AF-D58B-F9DA92C9F6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6658D8-06AE-0B45-BE9B-BE7BDC166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255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A459DAB-4431-D5D4-5594-1ACA12163E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355" y="423693"/>
            <a:ext cx="5502050" cy="267573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92C5B81-23C5-9C22-9A5E-B34119B45D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355" y="3543300"/>
            <a:ext cx="5680260" cy="267573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3B91662-9081-1CEA-FBB1-AA508A2D87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16778" y="3543300"/>
            <a:ext cx="5550102" cy="267573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72E1B24-17C9-D017-B881-0FA8D57E2972}"/>
              </a:ext>
            </a:extLst>
          </p:cNvPr>
          <p:cNvSpPr txBox="1"/>
          <p:nvPr/>
        </p:nvSpPr>
        <p:spPr>
          <a:xfrm>
            <a:off x="728081" y="54361"/>
            <a:ext cx="854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ch-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53FC525-27A6-8C44-2B3D-BA1454AC22EB}"/>
              </a:ext>
            </a:extLst>
          </p:cNvPr>
          <p:cNvSpPr txBox="1"/>
          <p:nvPr/>
        </p:nvSpPr>
        <p:spPr>
          <a:xfrm>
            <a:off x="728081" y="3173968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ch-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B3D6974-A85D-8EE1-3FB5-D20BDE491EC5}"/>
              </a:ext>
            </a:extLst>
          </p:cNvPr>
          <p:cNvSpPr txBox="1"/>
          <p:nvPr/>
        </p:nvSpPr>
        <p:spPr>
          <a:xfrm>
            <a:off x="7251784" y="3173968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ch-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78C7BA-B8A4-7650-0504-30B0191DC134}"/>
              </a:ext>
            </a:extLst>
          </p:cNvPr>
          <p:cNvSpPr txBox="1"/>
          <p:nvPr/>
        </p:nvSpPr>
        <p:spPr>
          <a:xfrm>
            <a:off x="7048983" y="1742807"/>
            <a:ext cx="43062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ure S1.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he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ss spectrum patterns of thre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. </a:t>
            </a:r>
            <a:r>
              <a:rPr lang="en-US" sz="1200" b="1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iricola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strain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e primary spectrum was compared to the VITEK MS MS-ID database (version 2.0) for identification</a:t>
            </a:r>
            <a:r>
              <a: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8822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4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icheng Chen</dc:creator>
  <cp:lastModifiedBy>Abby Rassette</cp:lastModifiedBy>
  <cp:revision>2</cp:revision>
  <dcterms:created xsi:type="dcterms:W3CDTF">2025-01-03T17:29:10Z</dcterms:created>
  <dcterms:modified xsi:type="dcterms:W3CDTF">2025-06-24T08:30:13Z</dcterms:modified>
</cp:coreProperties>
</file>